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  <p15:guide id="3" pos="121" userDrawn="1">
          <p15:clr>
            <a:srgbClr val="A4A3A4"/>
          </p15:clr>
        </p15:guide>
        <p15:guide id="4" orient="horz" pos="4178" userDrawn="1">
          <p15:clr>
            <a:srgbClr val="A4A3A4"/>
          </p15:clr>
        </p15:guide>
        <p15:guide id="5" orient="horz" pos="50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78" d="100"/>
          <a:sy n="78" d="100"/>
        </p:scale>
        <p:origin x="180" y="52"/>
      </p:cViewPr>
      <p:guideLst>
        <p:guide orient="horz" pos="2160"/>
        <p:guide pos="3840"/>
        <p:guide pos="121"/>
        <p:guide orient="horz" pos="4178"/>
        <p:guide orient="horz" pos="5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702662-9D14-49AD-B4F8-096FAC3B692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da-DK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40038DE-7606-4E05-AB85-632ADB7C948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da-D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9CD592-1C4A-4405-B51F-191C494E4D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0BA96-4ABC-42DC-AE62-64014B102C8E}" type="datetimeFigureOut">
              <a:rPr lang="da-DK" smtClean="0"/>
              <a:t>28-10-2022</a:t>
            </a:fld>
            <a:endParaRPr lang="da-D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5E4FA3-C1A2-44F1-91A2-F88BD7F143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898007-901E-4A18-8240-0B75A50A9F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F48B0-AD60-490C-8330-05B887A3744A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4499833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94748A-19E7-496D-826B-18241A6940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a-DK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172C110-B498-4F88-9CE8-A098BEAD70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a-D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3313B9-5C37-4D94-A94A-D0BC6A1CAB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0BA96-4ABC-42DC-AE62-64014B102C8E}" type="datetimeFigureOut">
              <a:rPr lang="da-DK" smtClean="0"/>
              <a:t>28-10-2022</a:t>
            </a:fld>
            <a:endParaRPr lang="da-D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9DB8F7-4E3D-44D1-8C2B-992307B7EF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E66B2C-192B-4DF3-B0C0-D2954E1B6A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F48B0-AD60-490C-8330-05B887A3744A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6460635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E6A1AE5-022A-4EBE-9F43-6D3A73CB6FA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da-DK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B19B563-5115-4F42-BF58-545AF8D492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a-D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3B33E1-E06F-431E-925B-099A2BF2F0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0BA96-4ABC-42DC-AE62-64014B102C8E}" type="datetimeFigureOut">
              <a:rPr lang="da-DK" smtClean="0"/>
              <a:t>28-10-2022</a:t>
            </a:fld>
            <a:endParaRPr lang="da-D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CBC804-B48C-4CCC-A282-32A4876FD0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F8D95A-F6E0-46D8-9773-05D9BD4651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F48B0-AD60-490C-8330-05B887A3744A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5331719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9149C5-3ED8-437C-91B2-079F4FC544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a-DK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8BDC91-72A2-4D93-A995-EFC51882E83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a-D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DD04A3-9357-4837-A8FE-1E7D2EE353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0BA96-4ABC-42DC-AE62-64014B102C8E}" type="datetimeFigureOut">
              <a:rPr lang="da-DK" smtClean="0"/>
              <a:t>28-10-2022</a:t>
            </a:fld>
            <a:endParaRPr lang="da-D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2FEF31-A978-43F5-A8E5-992519C4DB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C65D54-D15D-49BD-AB48-C097FB4B31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F48B0-AD60-490C-8330-05B887A3744A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4583906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530400-C6FE-47DF-84AB-C6B04015E6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da-DK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3F7969D-E644-472E-BE71-73F1F2034D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C12EDC-4A4A-4D57-B2F4-B0301AF523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0BA96-4ABC-42DC-AE62-64014B102C8E}" type="datetimeFigureOut">
              <a:rPr lang="da-DK" smtClean="0"/>
              <a:t>28-10-2022</a:t>
            </a:fld>
            <a:endParaRPr lang="da-D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59982E-E643-408B-A961-6B87AC4374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267C5A-00A0-485E-8D31-72BFF6DA42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F48B0-AD60-490C-8330-05B887A3744A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8393945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000852-3317-46B9-82B7-E1C518DC18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a-DK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4ABC01F-6D73-44DB-9E0C-539CC4A23ED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a-DK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237D3E7-825E-4EC9-8B41-B49B119A3C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a-DK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270C175-3B27-4E1A-B9B7-0C93937655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0BA96-4ABC-42DC-AE62-64014B102C8E}" type="datetimeFigureOut">
              <a:rPr lang="da-DK" smtClean="0"/>
              <a:t>28-10-2022</a:t>
            </a:fld>
            <a:endParaRPr lang="da-DK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B45F358-EBB0-4406-8BF2-A13BF61488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09E06A-7C2C-44DF-88C2-1C9340B190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F48B0-AD60-490C-8330-05B887A3744A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6394074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B7F7DC-8F9F-4393-8526-43BF4E9532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da-DK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A72ED0-4A8C-4CA4-9821-645C42CDBD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F065CF7-7B55-4863-9971-7AE39A061E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a-DK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DDC7A9F-1256-4025-B2F7-E6ACAF2E5AF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AF1E12F-F765-4160-A34C-86FAE55E334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a-DK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95AC7CA-72D7-4B57-9F7B-76F1A9B073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0BA96-4ABC-42DC-AE62-64014B102C8E}" type="datetimeFigureOut">
              <a:rPr lang="da-DK" smtClean="0"/>
              <a:t>28-10-2022</a:t>
            </a:fld>
            <a:endParaRPr lang="da-DK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D06D786-2C69-45A1-8411-F842523E0D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0B1C994-AE9F-433B-945A-381D835AE9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F48B0-AD60-490C-8330-05B887A3744A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7784307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7A6AD1-5CAD-449C-9D81-3D4AC8ACDC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a-DK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3DF8ACF-97C0-431F-BF39-B7D45623EA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0BA96-4ABC-42DC-AE62-64014B102C8E}" type="datetimeFigureOut">
              <a:rPr lang="da-DK" smtClean="0"/>
              <a:t>28-10-2022</a:t>
            </a:fld>
            <a:endParaRPr lang="da-DK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5A56FCC-D399-4C62-955B-6BA7484949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5943D25-DF06-44EC-8537-068BC4D4F6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F48B0-AD60-490C-8330-05B887A3744A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2524358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D13ADB2-49D7-4276-B0AB-2FC36C2474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0BA96-4ABC-42DC-AE62-64014B102C8E}" type="datetimeFigureOut">
              <a:rPr lang="da-DK" smtClean="0"/>
              <a:t>28-10-2022</a:t>
            </a:fld>
            <a:endParaRPr lang="da-DK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7188B24-D49E-42D4-BC37-B7B75EC3EF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F6CAC8B-BDFA-4874-BF81-7EB27355FF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F48B0-AD60-490C-8330-05B887A3744A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0805197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0C90A3-9380-4D2C-966E-9656C709A1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a-DK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17B2A1-3A17-4744-B31E-F19507DB11E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a-DK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36353B-69CC-42A9-BA80-B66A6C08BE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2A82552-DA92-4075-9220-729D69615D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0BA96-4ABC-42DC-AE62-64014B102C8E}" type="datetimeFigureOut">
              <a:rPr lang="da-DK" smtClean="0"/>
              <a:t>28-10-2022</a:t>
            </a:fld>
            <a:endParaRPr lang="da-DK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81E1CDA-0813-4BF1-8845-C426B61B95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E64F491-AC81-473F-AA69-E9DA2B1E77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F48B0-AD60-490C-8330-05B887A3744A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9732578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2DD6D8-0FA7-4235-AA9A-BBB6631F5F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a-DK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A622C8A-6ED2-4DDF-99EB-4C3094D6597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F628C08-DA4A-4794-930A-5880D3CB2D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AE203BF-4C80-4D47-8C4C-0AA49EF7F1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0BA96-4ABC-42DC-AE62-64014B102C8E}" type="datetimeFigureOut">
              <a:rPr lang="da-DK" smtClean="0"/>
              <a:t>28-10-2022</a:t>
            </a:fld>
            <a:endParaRPr lang="da-DK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F9E068-25D8-4871-90B3-67812DD8F2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EFA69ED-664C-4062-B967-0067A096F7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F48B0-AD60-490C-8330-05B887A3744A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3071701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73EFBD5-DDF6-4879-A885-F3B9B42193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da-DK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32DDD6-D00A-46F5-9655-D0BA1E5767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a-D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53E88A-AEF9-46F1-A6DC-61B99E0EFCF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F0BA96-4ABC-42DC-AE62-64014B102C8E}" type="datetimeFigureOut">
              <a:rPr lang="da-DK" smtClean="0"/>
              <a:t>28-10-2022</a:t>
            </a:fld>
            <a:endParaRPr lang="da-D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4AE662-74D7-431F-AD03-3F0AD904A3C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C7DCEE-2173-4C4A-A8AA-BD997993110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3F48B0-AD60-490C-8330-05B887A3744A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0533670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B189A2-0860-4759-801C-FF35C0D06D5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2571001"/>
            <a:ext cx="9144000" cy="1715997"/>
          </a:xfrm>
        </p:spPr>
        <p:txBody>
          <a:bodyPr>
            <a:normAutofit fontScale="90000"/>
          </a:bodyPr>
          <a:lstStyle/>
          <a:p>
            <a:r>
              <a:rPr lang="en-US" dirty="0"/>
              <a:t>Sequences and alignments for dot blot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2085D27-2D4E-47DB-BA8D-F25A2123C70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44828" y="4943186"/>
            <a:ext cx="4163006" cy="2286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64944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24C806-82F4-4C47-96E4-C1914E364E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0554" y="129995"/>
            <a:ext cx="10515600" cy="444772"/>
          </a:xfrm>
        </p:spPr>
        <p:txBody>
          <a:bodyPr>
            <a:normAutofit fontScale="90000"/>
          </a:bodyPr>
          <a:lstStyle/>
          <a:p>
            <a:r>
              <a:rPr lang="da-DK" sz="4000" dirty="0"/>
              <a:t>Fig.6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CD6A837-3B09-4653-B218-882461E87434}"/>
              </a:ext>
            </a:extLst>
          </p:cNvPr>
          <p:cNvSpPr txBox="1"/>
          <p:nvPr/>
        </p:nvSpPr>
        <p:spPr>
          <a:xfrm>
            <a:off x="128587" y="843677"/>
            <a:ext cx="5371012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&gt;XP_025087911.1 keratin-</a:t>
            </a:r>
            <a:r>
              <a:rPr lang="da-DK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associated</a:t>
            </a:r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protein 19-2-like [</a:t>
            </a:r>
            <a:r>
              <a:rPr lang="da-DK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Pomacea</a:t>
            </a:r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da-DK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canaliculata</a:t>
            </a:r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] | 99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MKTVIALLLCALVASAMGGNLLGGYGYGYGLGLGGLGGAGYGGLGYGAGYGGLGYGAGYGGLGYGAGYGG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LGYGAGYGGLGYGAGYGGVGYGVGVGKRG</a:t>
            </a:r>
          </a:p>
          <a:p>
            <a:endParaRPr lang="da-DK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&gt;KRTAP19-2 | ENSP00000335660 | 52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MCYGYGCGCGSFCRLGYGCGYEGCRYGCGHRGCGDGCCCPSCYRRYRFTGFY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81EB60FE-2823-4BF9-A42F-E261813A52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6000" y="843677"/>
            <a:ext cx="6096000" cy="1089536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7C85DB1F-BD71-478D-A4F0-3622E1E1417B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8587" y="2677160"/>
            <a:ext cx="5274945" cy="3955415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8095604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24C806-82F4-4C47-96E4-C1914E364E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0554" y="129995"/>
            <a:ext cx="10515600" cy="444772"/>
          </a:xfrm>
        </p:spPr>
        <p:txBody>
          <a:bodyPr>
            <a:normAutofit fontScale="90000"/>
          </a:bodyPr>
          <a:lstStyle/>
          <a:p>
            <a:r>
              <a:rPr lang="da-DK" sz="4000" dirty="0"/>
              <a:t>Fig.6B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90FBF62-142E-44F4-8BE7-A55522563CC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78386" y="816005"/>
            <a:ext cx="6100403" cy="395867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AB4D5DC-60F5-48BA-9E3C-B587D4340156}"/>
              </a:ext>
            </a:extLst>
          </p:cNvPr>
          <p:cNvSpPr txBox="1"/>
          <p:nvPr/>
        </p:nvSpPr>
        <p:spPr>
          <a:xfrm>
            <a:off x="202474" y="860636"/>
            <a:ext cx="5135880" cy="20621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&gt;XP_032242219.1 keratin-</a:t>
            </a:r>
            <a:r>
              <a:rPr lang="da-DK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associated</a:t>
            </a:r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protein 5-1 [Nematostella </a:t>
            </a:r>
            <a:r>
              <a:rPr lang="da-DK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vectensis</a:t>
            </a:r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] | 441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MTFMLVWCIVVGCCMAYLHPGAVADLPSCQEIKGNSTAQVCIDGNCTFNCSRNMGYGSCDQLCLQNKDQK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PCPRLKCAASTCNQRCLSGGCTDVACNSHTCLQTCTSNCTNMECHSNTKCTQECEDGACGLATSGSGKAE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QICRGVGCKRMQCASAESCNQDCTRGCQLDCSNENTADCTQECKTGSCSFNCAAQTCESSCAHGSCPNMT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CGGTNCTQKCGKDCQQVVCSASGKCDQSCDGEGCNLYCSEGAKTCNQKCQGACVTDCKSRWCGVTCTGSG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CDVKCPNNGTESCDQTCQKSAGDCKMRCDAKVCTSKCTDGRCQAISCGGDRCTQECGKNCTSMACTAKSC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ELSCPGGGCIMSCSSSVENCTMSCPGGGCSQHCVATGKCNFDLDCKGCTISGNVPTSKTPSGGAGITATQ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SLLVGSAWLALSASRVHNFVV</a:t>
            </a:r>
          </a:p>
          <a:p>
            <a:endParaRPr lang="da-DK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&gt;KRTAP10-6 | ENSP00000383219 | 365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MAASTMSVCSSDLSYGSRVCLPGSCDSCSDSWQVDDCPESCCEPPCCAPAPCLSLVCTPVSRVSSPCCPV</a:t>
            </a:r>
            <a:b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</a:br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CEPSPCQSGCTSSCTPSCCQQSSCQLACCASSPCQQACCVPVCCKTVCCKPVCCVSVCCGDSSCCQQSS</a:t>
            </a:r>
            <a:b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</a:br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CQSACCTSSPCQQACCVPVCCKPVCSGISSSCCQQSSCVSCVSSPCCQAVCEPSPCQSGCTSSCTPSCCQ</a:t>
            </a:r>
            <a:b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</a:br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QSSCQPTCCTSSPCQQACCVPVCCVPVCCVPTCSEDSSSCCQQSSCQPACCTSSPCQHACCVPVCSGAST</a:t>
            </a:r>
            <a:b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</a:br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SCCQQSSCQPACCTASCCRSSSSVSLLCHPVCKSTCCVPVPSCGASASSCQPSCCRTASCVSLLCRPMCS</a:t>
            </a:r>
            <a:b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</a:br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RPACYSLCSGQKSSC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4F5062DC-8C55-4768-B536-E1FFE8A5DC41}"/>
              </a:ext>
            </a:extLst>
          </p:cNvPr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97" t="6165" r="6605" b="4902"/>
          <a:stretch/>
        </p:blipFill>
        <p:spPr bwMode="auto">
          <a:xfrm>
            <a:off x="202474" y="3114312"/>
            <a:ext cx="4746172" cy="3518263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5390072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24C806-82F4-4C47-96E4-C1914E364E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0554" y="129995"/>
            <a:ext cx="10515600" cy="444772"/>
          </a:xfrm>
        </p:spPr>
        <p:txBody>
          <a:bodyPr>
            <a:normAutofit fontScale="90000"/>
          </a:bodyPr>
          <a:lstStyle/>
          <a:p>
            <a:r>
              <a:rPr lang="da-DK" sz="4000" dirty="0"/>
              <a:t>Fig.6C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9D29445-0474-49A0-93F9-03E4DC0BEB34}"/>
              </a:ext>
            </a:extLst>
          </p:cNvPr>
          <p:cNvSpPr txBox="1"/>
          <p:nvPr/>
        </p:nvSpPr>
        <p:spPr>
          <a:xfrm>
            <a:off x="192088" y="785500"/>
            <a:ext cx="5815149" cy="1323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&gt;XP_028931377.1 keratin-</a:t>
            </a:r>
            <a:r>
              <a:rPr lang="da-DK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associated</a:t>
            </a:r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protein 4-3-like [</a:t>
            </a:r>
            <a:r>
              <a:rPr lang="da-DK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Ornithorhynchus</a:t>
            </a:r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da-DK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anatinus</a:t>
            </a:r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] | 222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MVNSCCGSVCSDLSCGRGCCQETCCQPSCCSSPCCPPTCCQTTCCRTTCCRPTCCRPTCCQPTCCRPICC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PCCRPTCCQTTCCRTTCCRPTCCVPTCCQPCCRPTCCQTTCCRTTCCRPTCCVPTCCQPSCCVSTCCRPC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CPPPCCGSSCCQPCCRPSCCLSSCCRPCCPPTCCVSSCCQPCCRPTCCQTTCCRTTCCRPSCCGSPCCQP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CCPPTCGPSCCC</a:t>
            </a:r>
          </a:p>
          <a:p>
            <a:endParaRPr lang="da-DK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&gt;XP_009918286.1 PREDICTED: keratin-</a:t>
            </a:r>
            <a:r>
              <a:rPr lang="da-DK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associated</a:t>
            </a:r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protein 4-3-like [</a:t>
            </a:r>
            <a:r>
              <a:rPr lang="da-DK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Haliaeetus</a:t>
            </a:r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da-DK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albicilla</a:t>
            </a:r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] | 195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MKLSCCIPSCCIPSCCIPSCCIPSCCIPSCCIPSCCIPSCCIPSCCIPSCCIPSCCIPSCCIPSCCIPSC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CIPSCCIPSCCIPSCCIPSCCIPSCCIPSCCIPSCCIPSCCIPSCCIPSCCIPSCCIPSCCIPSCCIPSC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CIPSCCIPSCCIPSCCIPSCCIPSCCIPSCCIPSCCIPSCFQIFMFSVHNKILFT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F693C8BE-BB14-449D-8A18-4AFCB1DAB33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07237" y="785500"/>
            <a:ext cx="6148251" cy="166717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DA61D58-A181-4AEB-A2D7-A9D427E84B1C}"/>
              </a:ext>
            </a:extLst>
          </p:cNvPr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46" t="6469" r="8269" b="7239"/>
          <a:stretch/>
        </p:blipFill>
        <p:spPr bwMode="auto">
          <a:xfrm>
            <a:off x="192088" y="3218814"/>
            <a:ext cx="4624251" cy="3413761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5160574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24C806-82F4-4C47-96E4-C1914E364E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0554" y="129995"/>
            <a:ext cx="10515600" cy="444772"/>
          </a:xfrm>
        </p:spPr>
        <p:txBody>
          <a:bodyPr>
            <a:normAutofit fontScale="90000"/>
          </a:bodyPr>
          <a:lstStyle/>
          <a:p>
            <a:r>
              <a:rPr lang="da-DK" sz="4000" dirty="0"/>
              <a:t>Fig.6D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B1F76ED-7C86-43C0-ADB6-540F049F7CF8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2088" y="2676525"/>
            <a:ext cx="5273675" cy="3956050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06B3BF5-15C3-4D6C-9A8B-3CAB7935AA1C}"/>
              </a:ext>
            </a:extLst>
          </p:cNvPr>
          <p:cNvSpPr txBox="1"/>
          <p:nvPr/>
        </p:nvSpPr>
        <p:spPr>
          <a:xfrm>
            <a:off x="192088" y="800100"/>
            <a:ext cx="573845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&gt;KRTAP4-3 | ENSP00000375151 | 195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MVSSCCGSVCSDQSCGQGLGQESCCRPSCCQTTCCRTTCCRPSCCISSCCRPSCCISSCCKPSCCRTTCC</a:t>
            </a:r>
            <a:b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</a:br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RPSCCISSCCRPSCCISSCCKPSCCRTTCCRPSCCISSCCRPSCCISSCCKPSCCQTTCCRPSCCISSCY</a:t>
            </a:r>
            <a:b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</a:br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RPQCCQPSCCRPACCISSCCHPSCCVSSCRCPFSCPTTCCRTTCFHPICCGSSCC</a:t>
            </a:r>
          </a:p>
          <a:p>
            <a:endParaRPr lang="da-DK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&gt;XP_009918286.1 PREDICTED: keratin-</a:t>
            </a:r>
            <a:r>
              <a:rPr lang="da-DK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associated</a:t>
            </a:r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protein 4-3-like [</a:t>
            </a:r>
            <a:r>
              <a:rPr lang="da-DK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Haliaeetus</a:t>
            </a:r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da-DK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albicilla</a:t>
            </a:r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] | 195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MKLSCCIPSCCIPSCCIPSCCIPSCCIPSCCIPSCCIPSCCIPSCCIPSCCIPSCCIPSCCIPSCCIPSC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CIPSCCIPSCCIPSCCIPSCCIPSCCIPSCCIPSCCIPSCCIPSCCIPSCCIPSCCIPSCCIPSCCIPSC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CIPSCCIPSCCIPSCCIPSCCIPSCCIPSCCIPSCCIPSCFQIFMFSVHNKILFT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DF7E7B11-5D7B-43CC-8397-121E45F4D62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78961" y="800100"/>
            <a:ext cx="6183812" cy="16625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1003916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24C806-82F4-4C47-96E4-C1914E364E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0554" y="129995"/>
            <a:ext cx="10515600" cy="444772"/>
          </a:xfrm>
        </p:spPr>
        <p:txBody>
          <a:bodyPr>
            <a:normAutofit fontScale="90000"/>
          </a:bodyPr>
          <a:lstStyle/>
          <a:p>
            <a:r>
              <a:rPr lang="da-DK" sz="4000" dirty="0"/>
              <a:t>Fig.6E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27D6BDE-8450-41CE-87F4-2E61F5D8E7C3}"/>
              </a:ext>
            </a:extLst>
          </p:cNvPr>
          <p:cNvSpPr txBox="1"/>
          <p:nvPr/>
        </p:nvSpPr>
        <p:spPr>
          <a:xfrm>
            <a:off x="192088" y="871252"/>
            <a:ext cx="614825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&gt;KRTAP4-7 | ENSP00000375236 | 155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MVSSCCGSVCSDQGCSQDLCQETCCRPSCCQTTCCRTTCYRPSCCVSSCCRPQCCQSVCCQPTCCRPTCC</a:t>
            </a:r>
            <a:b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</a:br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ETTCCHPRCCISSCCRPSCCMSSCCKPQCCQSVCCQPTCCRPSCCRPCCCLRPVCGRVSCHTTCYRPTCV</a:t>
            </a:r>
            <a:b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</a:br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ISTCPRPLCCASSCC</a:t>
            </a:r>
          </a:p>
          <a:p>
            <a:endParaRPr lang="da-DK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&gt;NXN92838.1 KRA43 protein, </a:t>
            </a:r>
            <a:r>
              <a:rPr lang="da-DK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partial</a:t>
            </a:r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[</a:t>
            </a:r>
            <a:r>
              <a:rPr lang="da-DK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Rhinopomastus</a:t>
            </a:r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da-DK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cyanomelas</a:t>
            </a:r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] | 197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CCRPHCCRPHCCRPHCCRPHCCRPHCCRPHCCRPHCCRPHCCRPHCCRPHCCRPHCCRPHCCRPHCCRPH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CCRPHCCRPHCCRPHCCRPHCCRPHCCRPHCCRPHCCRPHCCRPHCCRPHCCRPHCCRPHCCRPHCCRPH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CCRPHCCRPHCCRPHCCRPHCCRPHCCRPHCCRPHCCRPHCCRPHCCRPHCCRPHCC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1C15FB73-B6C1-4182-9603-55A607DA29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17623" y="800100"/>
            <a:ext cx="6096000" cy="161026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379E245-0AEF-4DFC-A7FE-D19D5D2BC759}"/>
              </a:ext>
            </a:extLst>
          </p:cNvPr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32" t="6514" r="5411" b="9822"/>
          <a:stretch/>
        </p:blipFill>
        <p:spPr bwMode="auto">
          <a:xfrm>
            <a:off x="192088" y="3323318"/>
            <a:ext cx="4850675" cy="3309257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24449634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24C806-82F4-4C47-96E4-C1914E364E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0554" y="129995"/>
            <a:ext cx="10515600" cy="444772"/>
          </a:xfrm>
        </p:spPr>
        <p:txBody>
          <a:bodyPr>
            <a:normAutofit fontScale="90000"/>
          </a:bodyPr>
          <a:lstStyle/>
          <a:p>
            <a:r>
              <a:rPr lang="da-DK" sz="4000" dirty="0"/>
              <a:t>Fig.6F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33C89BA-47CF-4D29-BF45-8322E033D62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6000" y="129995"/>
            <a:ext cx="6096000" cy="446345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87A9239-F0E0-42E1-9403-15E36D333EBB}"/>
              </a:ext>
            </a:extLst>
          </p:cNvPr>
          <p:cNvSpPr txBox="1"/>
          <p:nvPr/>
        </p:nvSpPr>
        <p:spPr>
          <a:xfrm>
            <a:off x="192088" y="800100"/>
            <a:ext cx="5009605" cy="19389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&gt;XP_047135497.1 keratin-</a:t>
            </a:r>
            <a:r>
              <a:rPr lang="da-DK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associated</a:t>
            </a:r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protein 10-4-like [Hydra </a:t>
            </a:r>
            <a:r>
              <a:rPr lang="da-DK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vulgaris</a:t>
            </a:r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] | 584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MYVNKSLRRGICPCTSYCNNYFCTDYCCTDYCCTDYCCTDYCCTDYCCTDYCCTDYCCTDYCCTDYCCTD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YCCTDYCCTDYCCTDYCCTDYCCTDYCCTDYCCTDYCCTDYCCTDYCCTDYCCTDYCCTDYCCTDYCCTD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YCCTDYCCTDYCCTDYCCTDYCCTDYCCTDYCCTDYCCTDYCCTDYCCTDYCCTDYCCTDYCCTDYCCTD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YCCTDYCCTDYCCTDYCCTDYCCTDYCCTDYCCTDYCCTDYCCTDYCCTDYCCTDYCCTDYCCTDYCCTD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YCCTDYCCTDYCCTDYCCTDYCCTDYCCTDYCCTDYCCTDYCCTDYCCTDYCCTDYCCTDYCCTDYCCTD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YCCTDYCCTDYCCTDYCCTDYCCTDYCCTDYCCTDYCCTDYCCTDYCCTDYCCTDYCCTDYCCTDYCCTD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YCCTDYCCTDYCCTDYCCTDYCCTDYCCTDYCCTDYCCTDYCCTDYCCTDYCCTDYCCTDYCCTDYCCTD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YCCTDYCCTDYCCTDYCCTDYCCTDYCCTDYCCTDYCCTDYCCTDYCCTDYCCTDYCCTDYCCTDYCCTD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YCCTDYCCTDYCCTDYCCKRIFVV</a:t>
            </a:r>
          </a:p>
          <a:p>
            <a:endParaRPr lang="da-DK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&gt;NXN92838.1 KRA43 protein, </a:t>
            </a:r>
            <a:r>
              <a:rPr lang="da-DK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partial</a:t>
            </a:r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[</a:t>
            </a:r>
            <a:r>
              <a:rPr lang="da-DK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Rhinopomastus</a:t>
            </a:r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da-DK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cyanomelas</a:t>
            </a:r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]  | 197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CCRPHCCRPHCCRPHCCRPHCCRPHCCRPHCCRPHCCRPHCCRPHCCRPHCCRPHCCRPHCCRPHCCRPH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CCRPHCCRPHCCRPHCCRPHCCRPHCCRPHCCRPHCCRPHCCRPHCCRPHCCRPHCCRPHCCRPHCCRPH</a:t>
            </a:r>
          </a:p>
          <a:p>
            <a:r>
              <a:rPr lang="da-DK" sz="800" dirty="0">
                <a:latin typeface="Courier New" panose="02070309020205020404" pitchFamily="49" charset="0"/>
                <a:cs typeface="Courier New" panose="02070309020205020404" pitchFamily="49" charset="0"/>
              </a:rPr>
              <a:t>CCRPHCCRPHCCRPHCCRPHCCRPHCCRPHCCRPHCCRPHCCRPHCCRPHCCRPHCC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74E28642-D369-4C72-AC91-552C79760B39}"/>
              </a:ext>
            </a:extLst>
          </p:cNvPr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90" t="4934" r="4454" b="8828"/>
          <a:stretch/>
        </p:blipFill>
        <p:spPr bwMode="auto">
          <a:xfrm>
            <a:off x="192088" y="3084078"/>
            <a:ext cx="5094515" cy="3548497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40001377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137</Words>
  <Application>Microsoft Office PowerPoint</Application>
  <PresentationFormat>Widescreen</PresentationFormat>
  <Paragraphs>63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Courier New</vt:lpstr>
      <vt:lpstr>Office Theme</vt:lpstr>
      <vt:lpstr>Sequences and alignments for dot blots</vt:lpstr>
      <vt:lpstr>Fig.6A</vt:lpstr>
      <vt:lpstr>Fig.6B</vt:lpstr>
      <vt:lpstr>Fig.6C</vt:lpstr>
      <vt:lpstr>Fig.6D</vt:lpstr>
      <vt:lpstr>Fig.6E</vt:lpstr>
      <vt:lpstr>Fig.6F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equences and alignments for dot blots</dc:title>
  <dc:creator>Thomas Litman</dc:creator>
  <cp:lastModifiedBy>Hewlett-Packard Company</cp:lastModifiedBy>
  <cp:revision>4</cp:revision>
  <dcterms:created xsi:type="dcterms:W3CDTF">2022-08-20T20:23:58Z</dcterms:created>
  <dcterms:modified xsi:type="dcterms:W3CDTF">2022-10-28T14:00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f061b9f0-8104-4829-9a4c-b0eb99e4c8fa_Enabled">
    <vt:lpwstr>true</vt:lpwstr>
  </property>
  <property fmtid="{D5CDD505-2E9C-101B-9397-08002B2CF9AE}" pid="3" name="MSIP_Label_f061b9f0-8104-4829-9a4c-b0eb99e4c8fa_SetDate">
    <vt:lpwstr>2022-08-20T20:50:41Z</vt:lpwstr>
  </property>
  <property fmtid="{D5CDD505-2E9C-101B-9397-08002B2CF9AE}" pid="4" name="MSIP_Label_f061b9f0-8104-4829-9a4c-b0eb99e4c8fa_Method">
    <vt:lpwstr>Standard</vt:lpwstr>
  </property>
  <property fmtid="{D5CDD505-2E9C-101B-9397-08002B2CF9AE}" pid="5" name="MSIP_Label_f061b9f0-8104-4829-9a4c-b0eb99e4c8fa_Name">
    <vt:lpwstr>Internal use only v1</vt:lpwstr>
  </property>
  <property fmtid="{D5CDD505-2E9C-101B-9397-08002B2CF9AE}" pid="6" name="MSIP_Label_f061b9f0-8104-4829-9a4c-b0eb99e4c8fa_SiteId">
    <vt:lpwstr>d78f7362-832c-4715-8e12-cc7bd574144c</vt:lpwstr>
  </property>
  <property fmtid="{D5CDD505-2E9C-101B-9397-08002B2CF9AE}" pid="7" name="MSIP_Label_f061b9f0-8104-4829-9a4c-b0eb99e4c8fa_ActionId">
    <vt:lpwstr>7eff6376-28fe-4c09-b029-6afa6c4ac725</vt:lpwstr>
  </property>
  <property fmtid="{D5CDD505-2E9C-101B-9397-08002B2CF9AE}" pid="8" name="MSIP_Label_f061b9f0-8104-4829-9a4c-b0eb99e4c8fa_ContentBits">
    <vt:lpwstr>0</vt:lpwstr>
  </property>
</Properties>
</file>